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0" d="100"/>
          <a:sy n="80" d="100"/>
        </p:scale>
        <p:origin x="120" y="6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Ralph Wendt" userId="34b954855c3466fe" providerId="LiveId" clId="{452DC782-87DA-40A1-B6C5-5AE3FB24CBD7}"/>
    <pc:docChg chg="modSld">
      <pc:chgData name="Ralph Wendt" userId="34b954855c3466fe" providerId="LiveId" clId="{452DC782-87DA-40A1-B6C5-5AE3FB24CBD7}" dt="2025-03-04T15:31:34.706" v="8" actId="20577"/>
      <pc:docMkLst>
        <pc:docMk/>
      </pc:docMkLst>
      <pc:sldChg chg="modSp mod">
        <pc:chgData name="Ralph Wendt" userId="34b954855c3466fe" providerId="LiveId" clId="{452DC782-87DA-40A1-B6C5-5AE3FB24CBD7}" dt="2025-03-04T15:31:34.706" v="8" actId="20577"/>
        <pc:sldMkLst>
          <pc:docMk/>
          <pc:sldMk cId="941487926" sldId="256"/>
        </pc:sldMkLst>
        <pc:spChg chg="mod">
          <ac:chgData name="Ralph Wendt" userId="34b954855c3466fe" providerId="LiveId" clId="{452DC782-87DA-40A1-B6C5-5AE3FB24CBD7}" dt="2025-03-04T15:31:34.706" v="8" actId="20577"/>
          <ac:spMkLst>
            <pc:docMk/>
            <pc:sldMk cId="941487926" sldId="256"/>
            <ac:spMk id="6" creationId="{F6249560-BD35-4727-8F31-7095A2490966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84250414-2409-4266-AEDB-31B8F558740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Untertitel 2">
            <a:extLst>
              <a:ext uri="{FF2B5EF4-FFF2-40B4-BE49-F238E27FC236}">
                <a16:creationId xmlns:a16="http://schemas.microsoft.com/office/drawing/2014/main" id="{112805F2-8A2E-4369-B5AC-B420E3C548AD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de-DE"/>
              <a:t>Master-Untertitel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0FB5CAC-9116-4DAE-9778-A181A005E56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D8261686-C4F3-4F6D-A51B-BC07E465FD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4F58EC83-39E9-4ADA-A89B-B141458C45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8781973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79B4AD91-2F32-406E-91C4-37A5EEDFD9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6E8D4D96-88F2-42BF-8473-21BE82D7007D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74C7DEB-209D-478B-9A08-7702690950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002FF5F-EBF2-47E7-8EC7-2A7454D270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8E5492AC-F097-4BF5-80E7-74DB58275B7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674999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>
            <a:extLst>
              <a:ext uri="{FF2B5EF4-FFF2-40B4-BE49-F238E27FC236}">
                <a16:creationId xmlns:a16="http://schemas.microsoft.com/office/drawing/2014/main" id="{80D891AB-58DC-419F-B5EB-6B98B657C26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Vertikaler Textplatzhalter 2">
            <a:extLst>
              <a:ext uri="{FF2B5EF4-FFF2-40B4-BE49-F238E27FC236}">
                <a16:creationId xmlns:a16="http://schemas.microsoft.com/office/drawing/2014/main" id="{2716FE3B-1AC9-4DAF-8633-ECD1F7DB062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4A91C989-EC83-4C20-AD51-10055AC00C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CDC52853-1821-4646-A80D-11F02768900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943FCD68-0FE4-4A15-B911-5CEC2CCD69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042614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61461EA1-366B-47F6-8320-0E056F03F5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BF601B5D-2515-4F36-B47A-D339157BFA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9A672481-FD61-42D6-AC87-5944E46A57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E4D2DD3C-4027-4709-83AE-2139B42304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6A6FF113-A5AA-48CE-B7D3-09420F79FF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96875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F07830C2-690D-46F8-8B97-53738058328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19E0ECDA-8738-4EEE-8D4F-BF56AC06C8F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A9DB5D42-F449-45D8-B2A2-75ACA24D8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A0510EB8-ADBE-4F2B-9EB7-EF0B666336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EC68566-9CC6-46F0-9216-6567B7CF5B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748342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881D490-7D71-4040-B4C9-DB2B545E36C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892E521-06EC-4C11-9E5F-D2F15EC3CF5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79A218D-E4CB-4F3C-8A64-4B89DFBA7F5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36BBBCC0-4B90-46EB-A9C8-38B1F3BC0F3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FB965BE3-AEEE-4090-BF74-756D2D09E9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1968C4D2-EA2F-4293-89AC-BD8E4A6940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588559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08676689-368D-4CEB-AC43-E7910772DF6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ABE95FA5-FF15-4C7C-A108-30FC1355044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Inhaltsplatzhalter 3">
            <a:extLst>
              <a:ext uri="{FF2B5EF4-FFF2-40B4-BE49-F238E27FC236}">
                <a16:creationId xmlns:a16="http://schemas.microsoft.com/office/drawing/2014/main" id="{B2B578A6-539C-4BF3-8830-128F8757309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5" name="Textplatzhalter 4">
            <a:extLst>
              <a:ext uri="{FF2B5EF4-FFF2-40B4-BE49-F238E27FC236}">
                <a16:creationId xmlns:a16="http://schemas.microsoft.com/office/drawing/2014/main" id="{D5F934CA-091B-49EE-937C-9308E06FAB0B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Inhaltsplatzhalter 5">
            <a:extLst>
              <a:ext uri="{FF2B5EF4-FFF2-40B4-BE49-F238E27FC236}">
                <a16:creationId xmlns:a16="http://schemas.microsoft.com/office/drawing/2014/main" id="{8DAE0099-A5AC-4329-8020-54E4EF5DEB9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7" name="Datumsplatzhalter 6">
            <a:extLst>
              <a:ext uri="{FF2B5EF4-FFF2-40B4-BE49-F238E27FC236}">
                <a16:creationId xmlns:a16="http://schemas.microsoft.com/office/drawing/2014/main" id="{9D7C74B0-E401-4B47-BB4D-0B7F14F481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8" name="Fußzeilenplatzhalter 7">
            <a:extLst>
              <a:ext uri="{FF2B5EF4-FFF2-40B4-BE49-F238E27FC236}">
                <a16:creationId xmlns:a16="http://schemas.microsoft.com/office/drawing/2014/main" id="{A9A62F7B-DAB9-448D-80B6-BE49AB7D59A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>
            <a:extLst>
              <a:ext uri="{FF2B5EF4-FFF2-40B4-BE49-F238E27FC236}">
                <a16:creationId xmlns:a16="http://schemas.microsoft.com/office/drawing/2014/main" id="{12C1B248-1AEE-4C20-B5B5-B7EF85A4D1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3069983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BF861C5C-DD70-4F47-8BD8-704237DB7DF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Datumsplatzhalter 2">
            <a:extLst>
              <a:ext uri="{FF2B5EF4-FFF2-40B4-BE49-F238E27FC236}">
                <a16:creationId xmlns:a16="http://schemas.microsoft.com/office/drawing/2014/main" id="{54027BA4-386E-460A-8C3E-DDAAC91223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4" name="Fußzeilenplatzhalter 3">
            <a:extLst>
              <a:ext uri="{FF2B5EF4-FFF2-40B4-BE49-F238E27FC236}">
                <a16:creationId xmlns:a16="http://schemas.microsoft.com/office/drawing/2014/main" id="{2EBFE5DC-878E-4A5D-B69C-90D3B17B0D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>
            <a:extLst>
              <a:ext uri="{FF2B5EF4-FFF2-40B4-BE49-F238E27FC236}">
                <a16:creationId xmlns:a16="http://schemas.microsoft.com/office/drawing/2014/main" id="{6D031EA6-9C40-41C4-B1F1-EDAD5D2299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60743675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>
            <a:extLst>
              <a:ext uri="{FF2B5EF4-FFF2-40B4-BE49-F238E27FC236}">
                <a16:creationId xmlns:a16="http://schemas.microsoft.com/office/drawing/2014/main" id="{13296650-3654-4C75-8A24-325038A5A7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3" name="Fußzeilenplatzhalter 2">
            <a:extLst>
              <a:ext uri="{FF2B5EF4-FFF2-40B4-BE49-F238E27FC236}">
                <a16:creationId xmlns:a16="http://schemas.microsoft.com/office/drawing/2014/main" id="{77E26F84-F297-403E-A39A-826DC2D5A0D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>
            <a:extLst>
              <a:ext uri="{FF2B5EF4-FFF2-40B4-BE49-F238E27FC236}">
                <a16:creationId xmlns:a16="http://schemas.microsoft.com/office/drawing/2014/main" id="{68254105-3947-4CDF-9917-7392538CA6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1940971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1402ADDB-F0EA-4B8B-9534-E2F87BCA260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Inhaltsplatzhalter 2">
            <a:extLst>
              <a:ext uri="{FF2B5EF4-FFF2-40B4-BE49-F238E27FC236}">
                <a16:creationId xmlns:a16="http://schemas.microsoft.com/office/drawing/2014/main" id="{FF3A1C32-5D80-42D4-B7CA-F66C0B1BD6B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F7A3B4E4-C7B0-4034-B463-397CC67DC77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842362C7-3A8D-4B43-8A81-AAF07EC1C8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11B7BB26-DB72-4580-8EA5-1280AF8097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4A41555-6544-4CE7-9FE2-ABEE88267B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67147978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>
            <a:extLst>
              <a:ext uri="{FF2B5EF4-FFF2-40B4-BE49-F238E27FC236}">
                <a16:creationId xmlns:a16="http://schemas.microsoft.com/office/drawing/2014/main" id="{27483AF7-1315-46BB-903D-336B2AD5A6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de-DE"/>
              <a:t>Mastertitelformat bearbeiten</a:t>
            </a:r>
          </a:p>
        </p:txBody>
      </p:sp>
      <p:sp>
        <p:nvSpPr>
          <p:cNvPr id="3" name="Bildplatzhalter 2">
            <a:extLst>
              <a:ext uri="{FF2B5EF4-FFF2-40B4-BE49-F238E27FC236}">
                <a16:creationId xmlns:a16="http://schemas.microsoft.com/office/drawing/2014/main" id="{740B7D0F-1DC1-442E-8C0B-DC054A97E672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>
            <a:extLst>
              <a:ext uri="{FF2B5EF4-FFF2-40B4-BE49-F238E27FC236}">
                <a16:creationId xmlns:a16="http://schemas.microsoft.com/office/drawing/2014/main" id="{02AD136D-DE24-44DA-9D9F-D9737894B0C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umsplatzhalter 4">
            <a:extLst>
              <a:ext uri="{FF2B5EF4-FFF2-40B4-BE49-F238E27FC236}">
                <a16:creationId xmlns:a16="http://schemas.microsoft.com/office/drawing/2014/main" id="{D8676F1E-1AA3-4BB3-936E-917E02AE54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6" name="Fußzeilenplatzhalter 5">
            <a:extLst>
              <a:ext uri="{FF2B5EF4-FFF2-40B4-BE49-F238E27FC236}">
                <a16:creationId xmlns:a16="http://schemas.microsoft.com/office/drawing/2014/main" id="{AA88B507-47B4-42B6-A6A4-3057DDD510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>
            <a:extLst>
              <a:ext uri="{FF2B5EF4-FFF2-40B4-BE49-F238E27FC236}">
                <a16:creationId xmlns:a16="http://schemas.microsoft.com/office/drawing/2014/main" id="{A21C3816-25CB-48F4-800C-5FC86A1BAE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527653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>
            <a:extLst>
              <a:ext uri="{FF2B5EF4-FFF2-40B4-BE49-F238E27FC236}">
                <a16:creationId xmlns:a16="http://schemas.microsoft.com/office/drawing/2014/main" id="{F2DD0057-F0BE-405C-9091-648B5A00EF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</a:p>
        </p:txBody>
      </p:sp>
      <p:sp>
        <p:nvSpPr>
          <p:cNvPr id="3" name="Textplatzhalter 2">
            <a:extLst>
              <a:ext uri="{FF2B5EF4-FFF2-40B4-BE49-F238E27FC236}">
                <a16:creationId xmlns:a16="http://schemas.microsoft.com/office/drawing/2014/main" id="{BF30E324-C63C-40EF-B821-69AAFEE234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4" name="Datumsplatzhalter 3">
            <a:extLst>
              <a:ext uri="{FF2B5EF4-FFF2-40B4-BE49-F238E27FC236}">
                <a16:creationId xmlns:a16="http://schemas.microsoft.com/office/drawing/2014/main" id="{B7782D53-1184-44AD-AD57-B021A3EED1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16E382-6911-48B5-B3D8-C5440D48193D}" type="datetimeFigureOut">
              <a:rPr lang="de-DE" smtClean="0"/>
              <a:t>04.03.2025</a:t>
            </a:fld>
            <a:endParaRPr lang="de-DE"/>
          </a:p>
        </p:txBody>
      </p:sp>
      <p:sp>
        <p:nvSpPr>
          <p:cNvPr id="5" name="Fußzeilenplatzhalter 4">
            <a:extLst>
              <a:ext uri="{FF2B5EF4-FFF2-40B4-BE49-F238E27FC236}">
                <a16:creationId xmlns:a16="http://schemas.microsoft.com/office/drawing/2014/main" id="{2D8BE97A-480D-433D-B6E2-13F050DDE18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>
            <a:extLst>
              <a:ext uri="{FF2B5EF4-FFF2-40B4-BE49-F238E27FC236}">
                <a16:creationId xmlns:a16="http://schemas.microsoft.com/office/drawing/2014/main" id="{01A30694-9AD5-4959-87A8-F499D25BE53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86C90F-3C39-4640-B3C4-9FD5498774C0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4626120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>
            <a:extLst>
              <a:ext uri="{FF2B5EF4-FFF2-40B4-BE49-F238E27FC236}">
                <a16:creationId xmlns:a16="http://schemas.microsoft.com/office/drawing/2014/main" id="{9DE6D1C5-0424-42FD-ABE1-3EB86286D1A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226734" y="786385"/>
            <a:ext cx="7823200" cy="4242954"/>
          </a:xfrm>
          <a:prstGeom prst="rect">
            <a:avLst/>
          </a:prstGeom>
        </p:spPr>
      </p:pic>
      <p:sp>
        <p:nvSpPr>
          <p:cNvPr id="6" name="Textfeld 5">
            <a:extLst>
              <a:ext uri="{FF2B5EF4-FFF2-40B4-BE49-F238E27FC236}">
                <a16:creationId xmlns:a16="http://schemas.microsoft.com/office/drawing/2014/main" id="{F6249560-BD35-4727-8F31-7095A2490966}"/>
              </a:ext>
            </a:extLst>
          </p:cNvPr>
          <p:cNvSpPr txBox="1"/>
          <p:nvPr/>
        </p:nvSpPr>
        <p:spPr>
          <a:xfrm>
            <a:off x="2057400" y="4863254"/>
            <a:ext cx="7907866" cy="67550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457200" algn="just">
              <a:lnSpc>
                <a:spcPct val="107000"/>
              </a:lnSpc>
              <a:spcAft>
                <a:spcPts val="8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Suppl. </a:t>
            </a:r>
            <a:r>
              <a:rPr lang="en-US" sz="1200" b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Figure 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: Course 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f serum creatinine and urea in patients with community-acquired and nosocomial acquired infections  3 days before until max.18 days after rotavirus diagnosis. The day of rotavirus diagnosis is day 0. Means with 95% confidence intervals (black line: no AKI, red line = AKI, green area = normal range). </a:t>
            </a:r>
            <a:endParaRPr lang="de-DE" sz="16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414879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4</Words>
  <Application>Microsoft Office PowerPoint</Application>
  <PresentationFormat>Breitbild</PresentationFormat>
  <Paragraphs>1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alph Wendt</dc:creator>
  <cp:lastModifiedBy>Ralph Wendt</cp:lastModifiedBy>
  <cp:revision>3</cp:revision>
  <dcterms:created xsi:type="dcterms:W3CDTF">2025-01-13T16:53:33Z</dcterms:created>
  <dcterms:modified xsi:type="dcterms:W3CDTF">2025-03-04T15:31:37Z</dcterms:modified>
</cp:coreProperties>
</file>